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9" d="100"/>
          <a:sy n="49" d="100"/>
        </p:scale>
        <p:origin x="-2508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mst\Documents\Apoptosis%20Assay\Caspase-glo%20assay\Caspase150918&#12414;&#12392;&#1241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9</c:f>
              <c:strCache>
                <c:ptCount val="1"/>
                <c:pt idx="0">
                  <c:v>Normoxi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31:$D$31</c:f>
                <c:numCache>
                  <c:formatCode>General</c:formatCode>
                  <c:ptCount val="2"/>
                  <c:pt idx="0">
                    <c:v>3922.7358650139404</c:v>
                  </c:pt>
                  <c:pt idx="1">
                    <c:v>2555.41320859595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8:$D$28</c:f>
              <c:strCache>
                <c:ptCount val="2"/>
                <c:pt idx="0">
                  <c:v>Ctl</c:v>
                </c:pt>
                <c:pt idx="1">
                  <c:v>Anti-sense Oligo</c:v>
                </c:pt>
              </c:strCache>
            </c:strRef>
          </c:cat>
          <c:val>
            <c:numRef>
              <c:f>Sheet1!$C$29:$D$29</c:f>
              <c:numCache>
                <c:formatCode>General</c:formatCode>
                <c:ptCount val="2"/>
                <c:pt idx="0">
                  <c:v>50921.666666666664</c:v>
                </c:pt>
                <c:pt idx="1">
                  <c:v>55508.333333333336</c:v>
                </c:pt>
              </c:numCache>
            </c:numRef>
          </c:val>
        </c:ser>
        <c:ser>
          <c:idx val="1"/>
          <c:order val="1"/>
          <c:tx>
            <c:strRef>
              <c:f>Sheet1!$B$30</c:f>
              <c:strCache>
                <c:ptCount val="1"/>
                <c:pt idx="0">
                  <c:v>Hypoxi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32:$D$32</c:f>
                <c:numCache>
                  <c:formatCode>General</c:formatCode>
                  <c:ptCount val="2"/>
                  <c:pt idx="0">
                    <c:v>8233.3468285989256</c:v>
                  </c:pt>
                  <c:pt idx="1">
                    <c:v>8359.76734126016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8:$D$28</c:f>
              <c:strCache>
                <c:ptCount val="2"/>
                <c:pt idx="0">
                  <c:v>Ctl</c:v>
                </c:pt>
                <c:pt idx="1">
                  <c:v>Anti-sense Oligo</c:v>
                </c:pt>
              </c:strCache>
            </c:strRef>
          </c:cat>
          <c:val>
            <c:numRef>
              <c:f>Sheet1!$C$30:$D$30</c:f>
              <c:numCache>
                <c:formatCode>General</c:formatCode>
                <c:ptCount val="2"/>
                <c:pt idx="0">
                  <c:v>59510</c:v>
                </c:pt>
                <c:pt idx="1">
                  <c:v>74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552384"/>
        <c:axId val="185176832"/>
      </c:barChart>
      <c:catAx>
        <c:axId val="1775523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600" b="1"/>
            </a:pPr>
            <a:endParaRPr lang="ja-JP"/>
          </a:p>
        </c:txPr>
        <c:crossAx val="185176832"/>
        <c:crosses val="autoZero"/>
        <c:auto val="1"/>
        <c:lblAlgn val="ctr"/>
        <c:lblOffset val="100"/>
        <c:noMultiLvlLbl val="0"/>
      </c:catAx>
      <c:valAx>
        <c:axId val="185176832"/>
        <c:scaling>
          <c:orientation val="minMax"/>
          <c:max val="1000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7552384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739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603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319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1863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473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261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1903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0068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255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20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210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81466-9D35-442F-9D88-F2934AF3B704}" type="datetimeFigureOut">
              <a:rPr kumimoji="1" lang="ja-JP" altLang="en-US" smtClean="0"/>
              <a:t>2017/3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1FFDB-48FE-4F6B-A5C7-8E3DF44675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608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9418248"/>
              </p:ext>
            </p:extLst>
          </p:nvPr>
        </p:nvGraphicFramePr>
        <p:xfrm>
          <a:off x="1029699" y="1356157"/>
          <a:ext cx="4559541" cy="2135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2108277" y="1440022"/>
            <a:ext cx="1847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endParaRPr kumimoji="1" lang="ja-JP" altLang="en-US" sz="4000" dirty="0"/>
          </a:p>
        </p:txBody>
      </p:sp>
      <p:cxnSp>
        <p:nvCxnSpPr>
          <p:cNvPr id="5" name="直線コネクタ 4"/>
          <p:cNvCxnSpPr/>
          <p:nvPr/>
        </p:nvCxnSpPr>
        <p:spPr>
          <a:xfrm>
            <a:off x="2096473" y="1745933"/>
            <a:ext cx="4039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3490533" y="1509101"/>
            <a:ext cx="41950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2540396" y="1083191"/>
            <a:ext cx="136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3004624" y="656322"/>
            <a:ext cx="4395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dirty="0" smtClean="0"/>
              <a:t>*</a:t>
            </a:r>
            <a:endParaRPr kumimoji="1" lang="ja-JP" altLang="en-US" sz="4000" b="1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480515" y="1071316"/>
            <a:ext cx="4395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dirty="0" smtClean="0"/>
              <a:t>*</a:t>
            </a:r>
            <a:endParaRPr kumimoji="1" lang="ja-JP" altLang="en-US" sz="4000" b="1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060900" y="1320794"/>
            <a:ext cx="4395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b="1" dirty="0" smtClean="0"/>
              <a:t>*</a:t>
            </a:r>
            <a:endParaRPr kumimoji="1" lang="ja-JP" altLang="en-US" sz="4000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47821" y="286990"/>
            <a:ext cx="258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ry Figure S</a:t>
            </a:r>
            <a:r>
              <a:rPr lang="en-US" altLang="ja-JP" dirty="0" smtClean="0"/>
              <a:t>1</a:t>
            </a:r>
            <a:r>
              <a:rPr kumimoji="1" lang="en-US" altLang="ja-JP" dirty="0" smtClean="0"/>
              <a:t>.</a:t>
            </a:r>
            <a:endParaRPr kumimoji="1" lang="ja-JP" altLang="en-US" dirty="0"/>
          </a:p>
        </p:txBody>
      </p:sp>
      <p:cxnSp>
        <p:nvCxnSpPr>
          <p:cNvPr id="12" name="直線コネクタ 11"/>
          <p:cNvCxnSpPr/>
          <p:nvPr/>
        </p:nvCxnSpPr>
        <p:spPr>
          <a:xfrm rot="5400000">
            <a:off x="3834082" y="1581101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 rot="5400000">
            <a:off x="3418533" y="1579785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 rot="5400000">
            <a:off x="2430305" y="1809758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 rot="5400000">
            <a:off x="2014756" y="1808442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 rot="5400000">
            <a:off x="3826831" y="1149811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 rot="5400000">
            <a:off x="2458679" y="1148495"/>
            <a:ext cx="144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 rot="16200000">
            <a:off x="-133294" y="2085761"/>
            <a:ext cx="20760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Luminescence (RLU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91188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mari</dc:creator>
  <cp:lastModifiedBy>imari</cp:lastModifiedBy>
  <cp:revision>2</cp:revision>
  <dcterms:created xsi:type="dcterms:W3CDTF">2017-03-04T12:20:45Z</dcterms:created>
  <dcterms:modified xsi:type="dcterms:W3CDTF">2017-03-04T12:21:50Z</dcterms:modified>
</cp:coreProperties>
</file>